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1" r:id="rId2"/>
    <p:sldId id="262" r:id="rId3"/>
  </p:sldIdLst>
  <p:sldSz cx="12192000" cy="6858000"/>
  <p:notesSz cx="6858000" cy="9144000"/>
  <p:defaultTextStyle>
    <a:defPPr>
      <a:defRPr lang="he-I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275" userDrawn="1">
          <p15:clr>
            <a:srgbClr val="A4A3A4"/>
          </p15:clr>
        </p15:guide>
        <p15:guide id="2" pos="68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83544" autoAdjust="0"/>
  </p:normalViewPr>
  <p:slideViewPr>
    <p:cSldViewPr snapToGrid="0" showGuides="1">
      <p:cViewPr varScale="1">
        <p:scale>
          <a:sx n="90" d="100"/>
          <a:sy n="90" d="100"/>
        </p:scale>
        <p:origin x="888" y="90"/>
      </p:cViewPr>
      <p:guideLst>
        <p:guide orient="horz" pos="1275"/>
        <p:guide pos="68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6D378DB-A993-4192-8DC6-8E3C5F5DE46D}" type="datetimeFigureOut">
              <a:rPr lang="en-US" smtClean="0"/>
              <a:t>9/29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3A61DC2-25D0-4FF9-944F-45B3937917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42891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 smtClean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3A61DC2-25D0-4FF9-944F-45B3937917F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58383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7BF99-A9A6-4178-99AB-55257A1A6DD2}" type="datetimeFigureOut">
              <a:rPr lang="he-IL" smtClean="0"/>
              <a:t>י"א/תשרי/תשפ"א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A3BD73-9D98-48D3-93C4-BF656F939B1C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0139335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7BF99-A9A6-4178-99AB-55257A1A6DD2}" type="datetimeFigureOut">
              <a:rPr lang="he-IL" smtClean="0"/>
              <a:t>י"א/תשרי/תשפ"א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A3BD73-9D98-48D3-93C4-BF656F939B1C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9558580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7BF99-A9A6-4178-99AB-55257A1A6DD2}" type="datetimeFigureOut">
              <a:rPr lang="he-IL" smtClean="0"/>
              <a:t>י"א/תשרי/תשפ"א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A3BD73-9D98-48D3-93C4-BF656F939B1C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754812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7BF99-A9A6-4178-99AB-55257A1A6DD2}" type="datetimeFigureOut">
              <a:rPr lang="he-IL" smtClean="0"/>
              <a:t>י"א/תשרי/תשפ"א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A3BD73-9D98-48D3-93C4-BF656F939B1C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2078943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7BF99-A9A6-4178-99AB-55257A1A6DD2}" type="datetimeFigureOut">
              <a:rPr lang="he-IL" smtClean="0"/>
              <a:t>י"א/תשרי/תשפ"א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A3BD73-9D98-48D3-93C4-BF656F939B1C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7504508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7BF99-A9A6-4178-99AB-55257A1A6DD2}" type="datetimeFigureOut">
              <a:rPr lang="he-IL" smtClean="0"/>
              <a:t>י"א/תשרי/תשפ"א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A3BD73-9D98-48D3-93C4-BF656F939B1C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6145457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7BF99-A9A6-4178-99AB-55257A1A6DD2}" type="datetimeFigureOut">
              <a:rPr lang="he-IL" smtClean="0"/>
              <a:t>י"א/תשרי/תשפ"א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A3BD73-9D98-48D3-93C4-BF656F939B1C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1567855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7BF99-A9A6-4178-99AB-55257A1A6DD2}" type="datetimeFigureOut">
              <a:rPr lang="he-IL" smtClean="0"/>
              <a:t>י"א/תשרי/תשפ"א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A3BD73-9D98-48D3-93C4-BF656F939B1C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025562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7BF99-A9A6-4178-99AB-55257A1A6DD2}" type="datetimeFigureOut">
              <a:rPr lang="he-IL" smtClean="0"/>
              <a:t>י"א/תשרי/תשפ"א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A3BD73-9D98-48D3-93C4-BF656F939B1C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5604687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7BF99-A9A6-4178-99AB-55257A1A6DD2}" type="datetimeFigureOut">
              <a:rPr lang="he-IL" smtClean="0"/>
              <a:t>י"א/תשרי/תשפ"א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A3BD73-9D98-48D3-93C4-BF656F939B1C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8510520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7BF99-A9A6-4178-99AB-55257A1A6DD2}" type="datetimeFigureOut">
              <a:rPr lang="he-IL" smtClean="0"/>
              <a:t>י"א/תשרי/תשפ"א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A3BD73-9D98-48D3-93C4-BF656F939B1C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0476053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D7BF99-A9A6-4178-99AB-55257A1A6DD2}" type="datetimeFigureOut">
              <a:rPr lang="he-IL" smtClean="0"/>
              <a:t>י"א/תשרי/תשפ"א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A3BD73-9D98-48D3-93C4-BF656F939B1C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2165285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png"/><Relationship Id="rId3" Type="http://schemas.openxmlformats.org/officeDocument/2006/relationships/image" Target="../media/image17.png"/><Relationship Id="rId7" Type="http://schemas.openxmlformats.org/officeDocument/2006/relationships/image" Target="../media/image21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png"/><Relationship Id="rId11" Type="http://schemas.openxmlformats.org/officeDocument/2006/relationships/image" Target="../media/image25.png"/><Relationship Id="rId5" Type="http://schemas.openxmlformats.org/officeDocument/2006/relationships/image" Target="../media/image19.png"/><Relationship Id="rId10" Type="http://schemas.openxmlformats.org/officeDocument/2006/relationships/image" Target="../media/image24.png"/><Relationship Id="rId4" Type="http://schemas.openxmlformats.org/officeDocument/2006/relationships/image" Target="../media/image18.png"/><Relationship Id="rId9" Type="http://schemas.openxmlformats.org/officeDocument/2006/relationships/image" Target="../media/image2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483803" y="19801"/>
            <a:ext cx="1723542" cy="30777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 rtl="0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UT</a:t>
            </a:r>
            <a:endParaRPr lang="he-IL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5709275" y="35550"/>
            <a:ext cx="1708456" cy="30777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 rtl="0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D</a:t>
            </a:r>
            <a:endParaRPr lang="he-IL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30791" y="172244"/>
            <a:ext cx="2186940" cy="218694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057104" y="172244"/>
            <a:ext cx="2186940" cy="218694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057104" y="2349776"/>
            <a:ext cx="2186940" cy="218694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230791" y="2349776"/>
            <a:ext cx="2186940" cy="2186940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057104" y="4555580"/>
            <a:ext cx="2186940" cy="218694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230791" y="4555580"/>
            <a:ext cx="2186940" cy="2186940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2348388" y="-1"/>
            <a:ext cx="1787608" cy="30777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 rtl="0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D PBMC</a:t>
            </a:r>
            <a:endParaRPr lang="he-IL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8229600" y="-10211"/>
            <a:ext cx="1697654" cy="30777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 rtl="0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UT</a:t>
            </a:r>
            <a:endParaRPr lang="he-IL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0432724" y="24015"/>
            <a:ext cx="1688471" cy="307777"/>
          </a:xfrm>
          <a:prstGeom prst="rect">
            <a:avLst/>
          </a:prstGeom>
          <a:noFill/>
        </p:spPr>
        <p:txBody>
          <a:bodyPr wrap="square" rtlCol="1" anchor="t" anchorCtr="1">
            <a:spAutoFit/>
          </a:bodyPr>
          <a:lstStyle/>
          <a:p>
            <a:pPr algn="ctr" rtl="0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D</a:t>
            </a:r>
            <a:endParaRPr lang="he-IL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764369" y="187478"/>
            <a:ext cx="2186940" cy="2186940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0004490" y="187478"/>
            <a:ext cx="2186940" cy="2186940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764369" y="2361998"/>
            <a:ext cx="2186940" cy="2186940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0004490" y="2365957"/>
            <a:ext cx="2186940" cy="2186940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7764369" y="4555580"/>
            <a:ext cx="2186940" cy="2186940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0004490" y="4583610"/>
            <a:ext cx="2186940" cy="2186940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7046176" y="23078"/>
            <a:ext cx="1787608" cy="30777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 rtl="0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IL</a:t>
            </a:r>
            <a:endParaRPr lang="he-IL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Picture 21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534166" y="187478"/>
            <a:ext cx="2186940" cy="2186940"/>
          </a:xfrm>
          <a:prstGeom prst="rect">
            <a:avLst/>
          </a:prstGeom>
        </p:spPr>
      </p:pic>
      <p:sp>
        <p:nvSpPr>
          <p:cNvPr id="24" name="TextBox 23"/>
          <p:cNvSpPr txBox="1"/>
          <p:nvPr/>
        </p:nvSpPr>
        <p:spPr>
          <a:xfrm>
            <a:off x="963846" y="2700"/>
            <a:ext cx="1728408" cy="30777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 rtl="0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Unstained </a:t>
            </a:r>
            <a:endParaRPr lang="he-IL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534166" y="2354794"/>
            <a:ext cx="2186940" cy="218694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534166" y="4571239"/>
            <a:ext cx="2186940" cy="2186940"/>
          </a:xfrm>
          <a:prstGeom prst="rect">
            <a:avLst/>
          </a:prstGeom>
        </p:spPr>
      </p:pic>
      <p:sp>
        <p:nvSpPr>
          <p:cNvPr id="23" name="TextBox 22"/>
          <p:cNvSpPr txBox="1"/>
          <p:nvPr/>
        </p:nvSpPr>
        <p:spPr>
          <a:xfrm>
            <a:off x="210184" y="280052"/>
            <a:ext cx="324128" cy="3693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28" name="TextBox 27"/>
          <p:cNvSpPr txBox="1"/>
          <p:nvPr/>
        </p:nvSpPr>
        <p:spPr>
          <a:xfrm>
            <a:off x="216596" y="2460110"/>
            <a:ext cx="317716" cy="3693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  <p:sp>
        <p:nvSpPr>
          <p:cNvPr id="29" name="TextBox 28"/>
          <p:cNvSpPr txBox="1"/>
          <p:nvPr/>
        </p:nvSpPr>
        <p:spPr>
          <a:xfrm>
            <a:off x="227818" y="4728650"/>
            <a:ext cx="306494" cy="3693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b="1" dirty="0" smtClean="0"/>
              <a:t>C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42560403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483803" y="19801"/>
            <a:ext cx="1723542" cy="30777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 rtl="0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UT</a:t>
            </a:r>
            <a:endParaRPr lang="he-IL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5709275" y="35550"/>
            <a:ext cx="1708456" cy="30777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 rtl="0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D</a:t>
            </a:r>
            <a:endParaRPr lang="he-IL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965833" y="-1"/>
            <a:ext cx="1787608" cy="30777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 rtl="0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D PBMC</a:t>
            </a:r>
            <a:endParaRPr lang="he-IL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8229600" y="22063"/>
            <a:ext cx="1697654" cy="30777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 rtl="0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UT</a:t>
            </a:r>
            <a:endParaRPr lang="he-IL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0432724" y="24015"/>
            <a:ext cx="1688471" cy="307777"/>
          </a:xfrm>
          <a:prstGeom prst="rect">
            <a:avLst/>
          </a:prstGeom>
          <a:noFill/>
        </p:spPr>
        <p:txBody>
          <a:bodyPr wrap="square" rtlCol="1" anchor="t" anchorCtr="1">
            <a:spAutoFit/>
          </a:bodyPr>
          <a:lstStyle/>
          <a:p>
            <a:pPr algn="ctr" rtl="0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D</a:t>
            </a:r>
            <a:endParaRPr lang="he-IL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7046176" y="23078"/>
            <a:ext cx="1787608" cy="30777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 rtl="0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IL</a:t>
            </a:r>
            <a:endParaRPr lang="he-IL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88303" y="2700"/>
            <a:ext cx="1728408" cy="30777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 rtl="0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Unstained </a:t>
            </a:r>
            <a:endParaRPr lang="he-IL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9771" y="198484"/>
            <a:ext cx="2186940" cy="2186940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33153" y="182261"/>
            <a:ext cx="2186940" cy="2186940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682326" y="213526"/>
            <a:ext cx="2186940" cy="2186940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9096" y="2547149"/>
            <a:ext cx="2186940" cy="2186940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237600" y="2547149"/>
            <a:ext cx="2186940" cy="2186940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682326" y="2547149"/>
            <a:ext cx="2186940" cy="2186940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016865" y="182261"/>
            <a:ext cx="2186940" cy="2186940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9848191" y="198484"/>
            <a:ext cx="2186940" cy="2186940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046213" y="2547149"/>
            <a:ext cx="2186940" cy="2186940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9841190" y="2531661"/>
            <a:ext cx="2186940" cy="2186940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2401096" y="5380926"/>
            <a:ext cx="6096000" cy="1200329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fr-FR" b="1" dirty="0" err="1" smtClean="0"/>
              <a:t>Fig</a:t>
            </a:r>
            <a:r>
              <a:rPr lang="fr-FR" b="1" dirty="0" smtClean="0"/>
              <a:t> 2 suppl. </a:t>
            </a:r>
            <a:r>
              <a:rPr lang="fr-FR" dirty="0" err="1" smtClean="0"/>
              <a:t>Differentiation</a:t>
            </a:r>
            <a:r>
              <a:rPr lang="fr-FR" dirty="0" smtClean="0"/>
              <a:t> </a:t>
            </a:r>
            <a:r>
              <a:rPr lang="fr-FR" dirty="0"/>
              <a:t>statues (CD3+ /CCR7 vs </a:t>
            </a:r>
            <a:r>
              <a:rPr lang="fr-FR" dirty="0" smtClean="0"/>
              <a:t>CD45RA) (</a:t>
            </a:r>
            <a:r>
              <a:rPr lang="fr-FR" b="1" dirty="0" smtClean="0"/>
              <a:t>A</a:t>
            </a:r>
            <a:r>
              <a:rPr lang="fr-FR" dirty="0" smtClean="0"/>
              <a:t>) CD28 (</a:t>
            </a:r>
            <a:r>
              <a:rPr lang="fr-FR" b="1" dirty="0" smtClean="0"/>
              <a:t>B</a:t>
            </a:r>
            <a:r>
              <a:rPr lang="fr-FR" dirty="0" smtClean="0"/>
              <a:t>) and LAG-3 (</a:t>
            </a:r>
            <a:r>
              <a:rPr lang="fr-FR" b="1" dirty="0" smtClean="0"/>
              <a:t>C</a:t>
            </a:r>
            <a:r>
              <a:rPr lang="fr-FR" dirty="0" smtClean="0"/>
              <a:t>) expression </a:t>
            </a:r>
            <a:r>
              <a:rPr lang="fr-FR" dirty="0"/>
              <a:t>on T </a:t>
            </a:r>
            <a:r>
              <a:rPr lang="fr-FR" dirty="0" err="1"/>
              <a:t>cells</a:t>
            </a:r>
            <a:r>
              <a:rPr lang="fr-FR" dirty="0"/>
              <a:t> (</a:t>
            </a:r>
            <a:r>
              <a:rPr lang="fr-FR" dirty="0" smtClean="0"/>
              <a:t>CD3+)  </a:t>
            </a:r>
            <a:r>
              <a:rPr lang="fr-FR" dirty="0"/>
              <a:t>(</a:t>
            </a:r>
            <a:r>
              <a:rPr lang="fr-FR" dirty="0" smtClean="0"/>
              <a:t>TIL </a:t>
            </a:r>
            <a:r>
              <a:rPr lang="fr-FR" dirty="0"/>
              <a:t>189 and HD1 PBMC</a:t>
            </a:r>
            <a:r>
              <a:rPr lang="fr-FR" dirty="0" smtClean="0"/>
              <a:t>) TIM-3 (</a:t>
            </a:r>
            <a:r>
              <a:rPr lang="fr-FR" b="1" dirty="0" smtClean="0"/>
              <a:t>D</a:t>
            </a:r>
            <a:r>
              <a:rPr lang="fr-FR" dirty="0" smtClean="0"/>
              <a:t>) and PD1 (</a:t>
            </a:r>
            <a:r>
              <a:rPr lang="fr-FR" b="1" dirty="0" smtClean="0"/>
              <a:t>E</a:t>
            </a:r>
            <a:r>
              <a:rPr lang="fr-FR" dirty="0" smtClean="0"/>
              <a:t>) expression on T </a:t>
            </a:r>
            <a:r>
              <a:rPr lang="fr-FR" dirty="0" err="1" smtClean="0"/>
              <a:t>cells</a:t>
            </a:r>
            <a:r>
              <a:rPr lang="fr-FR" dirty="0" smtClean="0"/>
              <a:t> (CD3+) (TIL 052 and HD2 PBMC)</a:t>
            </a:r>
            <a:endParaRPr lang="fr-FR" dirty="0"/>
          </a:p>
        </p:txBody>
      </p:sp>
      <p:sp>
        <p:nvSpPr>
          <p:cNvPr id="24" name="TextBox 23"/>
          <p:cNvSpPr txBox="1"/>
          <p:nvPr/>
        </p:nvSpPr>
        <p:spPr>
          <a:xfrm>
            <a:off x="103856" y="205621"/>
            <a:ext cx="330540" cy="3693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b="1" dirty="0" smtClean="0"/>
              <a:t>D</a:t>
            </a:r>
            <a:endParaRPr lang="en-US" b="1" dirty="0"/>
          </a:p>
        </p:txBody>
      </p:sp>
      <p:sp>
        <p:nvSpPr>
          <p:cNvPr id="25" name="TextBox 24"/>
          <p:cNvSpPr txBox="1"/>
          <p:nvPr/>
        </p:nvSpPr>
        <p:spPr>
          <a:xfrm>
            <a:off x="103856" y="2524114"/>
            <a:ext cx="296876" cy="3693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b="1" dirty="0" smtClean="0"/>
              <a:t>E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7421130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0</TotalTime>
  <Words>85</Words>
  <Application>Microsoft Office PowerPoint</Application>
  <PresentationFormat>Widescreen</PresentationFormat>
  <Paragraphs>21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>Sheba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יצחקי אורית, דר</cp:lastModifiedBy>
  <cp:revision>21</cp:revision>
  <dcterms:created xsi:type="dcterms:W3CDTF">2020-09-09T15:12:18Z</dcterms:created>
  <dcterms:modified xsi:type="dcterms:W3CDTF">2020-09-29T10:12:35Z</dcterms:modified>
</cp:coreProperties>
</file>